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8" r:id="rId2"/>
    <p:sldId id="257" r:id="rId3"/>
    <p:sldId id="256" r:id="rId4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  <p:ext uri="{1BD7E111-0CB8-44D6-8891-C1BB2F81B7CC}">
      <p1710:readonlyRecommended xmlns:p1710="http://schemas.microsoft.com/office/powerpoint/2017/10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2" d="100"/>
          <a:sy n="72" d="100"/>
        </p:scale>
        <p:origin x="61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79BCFA-6DC9-48A4-A0BA-F839B4D4BE86}" type="datetimeFigureOut">
              <a:rPr lang="en-GB" smtClean="0"/>
              <a:t>12/02/2021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980322A-0209-46A3-B649-09A310AD19F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19984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5E713-9C48-4E2F-97D7-DD5500C488FE}" type="datetime1">
              <a:rPr lang="fr-FR" smtClean="0"/>
              <a:t>12/0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814C8-1B81-48EB-BA89-BCBB299676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21417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FF8CA-901E-44BF-8039-E164C5226C93}" type="datetime1">
              <a:rPr lang="fr-FR" smtClean="0"/>
              <a:t>12/0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814C8-1B81-48EB-BA89-BCBB299676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09858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BCD62-1F66-4BDE-8F03-EF8BA61AB2C9}" type="datetime1">
              <a:rPr lang="fr-FR" smtClean="0"/>
              <a:t>12/0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814C8-1B81-48EB-BA89-BCBB299676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877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72888-BBAB-4A48-9094-625983CE87FF}" type="datetime1">
              <a:rPr lang="fr-FR" smtClean="0"/>
              <a:t>12/0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814C8-1B81-48EB-BA89-BCBB299676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39983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03322-7D04-4CDA-97D5-5FA24456F19E}" type="datetime1">
              <a:rPr lang="fr-FR" smtClean="0"/>
              <a:t>12/0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814C8-1B81-48EB-BA89-BCBB299676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26146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CBD24-492A-4A78-AFD8-809825DE21D9}" type="datetime1">
              <a:rPr lang="fr-FR" smtClean="0"/>
              <a:t>12/02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814C8-1B81-48EB-BA89-BCBB299676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36112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215D3-03F3-4C43-BF83-9BE0ADC4A436}" type="datetime1">
              <a:rPr lang="fr-FR" smtClean="0"/>
              <a:t>12/02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814C8-1B81-48EB-BA89-BCBB299676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92072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E10CF-8CA0-4729-B951-F1AAE28511ED}" type="datetime1">
              <a:rPr lang="fr-FR" smtClean="0"/>
              <a:t>12/02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814C8-1B81-48EB-BA89-BCBB299676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24294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0416C-CF14-467B-B09C-57446C78C0AE}" type="datetime1">
              <a:rPr lang="fr-FR" smtClean="0"/>
              <a:t>12/02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814C8-1B81-48EB-BA89-BCBB299676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21573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FFAFD-35E7-44EA-B3E7-F84F285EC904}" type="datetime1">
              <a:rPr lang="fr-FR" smtClean="0"/>
              <a:t>12/02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814C8-1B81-48EB-BA89-BCBB299676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19441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759721-891D-40F9-9D17-9474F0D7A4ED}" type="datetime1">
              <a:rPr lang="fr-FR" smtClean="0"/>
              <a:t>12/02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814C8-1B81-48EB-BA89-BCBB299676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48661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8513D2-620E-4039-91C8-965BBEE043D7}" type="datetime1">
              <a:rPr lang="fr-FR" smtClean="0"/>
              <a:t>12/0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E814C8-1B81-48EB-BA89-BCBB299676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662746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microsoft.com/office/2007/relationships/media" Target="../media/media2.mp4"/><Relationship Id="rId7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5" Type="http://schemas.microsoft.com/office/2007/relationships/media" Target="../media/media3.mp4"/><Relationship Id="rId10" Type="http://schemas.openxmlformats.org/officeDocument/2006/relationships/image" Target="../media/image3.png"/><Relationship Id="rId4" Type="http://schemas.openxmlformats.org/officeDocument/2006/relationships/video" Target="../media/media2.mp4"/><Relationship Id="rId9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media" Target="../media/media5.mp4"/><Relationship Id="rId7" Type="http://schemas.openxmlformats.org/officeDocument/2006/relationships/slideLayout" Target="../slideLayouts/slideLayout1.xml"/><Relationship Id="rId2" Type="http://schemas.openxmlformats.org/officeDocument/2006/relationships/video" Target="../media/media4.mp4"/><Relationship Id="rId1" Type="http://schemas.microsoft.com/office/2007/relationships/media" Target="../media/media4.mp4"/><Relationship Id="rId6" Type="http://schemas.openxmlformats.org/officeDocument/2006/relationships/video" Target="../media/media6.mp4"/><Relationship Id="rId5" Type="http://schemas.microsoft.com/office/2007/relationships/media" Target="../media/media6.mp4"/><Relationship Id="rId10" Type="http://schemas.openxmlformats.org/officeDocument/2006/relationships/image" Target="../media/image6.png"/><Relationship Id="rId4" Type="http://schemas.openxmlformats.org/officeDocument/2006/relationships/video" Target="../media/media5.mp4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32D10D1C-5F00-41D8-B1AC-079A6E602A78}"/>
              </a:ext>
            </a:extLst>
          </p:cNvPr>
          <p:cNvSpPr txBox="1"/>
          <p:nvPr/>
        </p:nvSpPr>
        <p:spPr>
          <a:xfrm>
            <a:off x="490330" y="689788"/>
            <a:ext cx="11211340" cy="54784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spcAft>
                <a:spcPts val="1000"/>
              </a:spcAft>
            </a:pPr>
            <a:r>
              <a:rPr lang="en-GB" sz="20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aphylococcus aureus </a:t>
            </a:r>
            <a:r>
              <a:rPr lang="en-GB" sz="2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ternalization impairs osteoblastic activity and early differentiation process</a:t>
            </a:r>
            <a:endParaRPr lang="fr-FR" sz="20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1000"/>
              </a:spcAft>
            </a:pP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fr-FR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1000"/>
              </a:spcAft>
            </a:pPr>
            <a:r>
              <a:rPr lang="fr-FR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. Mouton</a:t>
            </a:r>
            <a:r>
              <a:rPr lang="fr-FR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2,†</a:t>
            </a:r>
            <a:r>
              <a:rPr lang="fr-FR" sz="14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fr-FR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J. Josse</a:t>
            </a:r>
            <a:r>
              <a:rPr lang="fr-FR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 3, †,*</a:t>
            </a:r>
            <a:r>
              <a:rPr lang="fr-FR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. Jacqueline</a:t>
            </a:r>
            <a:r>
              <a:rPr lang="fr-FR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fr-FR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L. Abad</a:t>
            </a:r>
            <a:r>
              <a:rPr lang="fr-FR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fr-FR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S. Trouillet-Assant-</a:t>
            </a:r>
            <a:r>
              <a:rPr lang="fr-FR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fr-FR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J. Caillon</a:t>
            </a:r>
            <a:r>
              <a:rPr lang="fr-FR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fr-FR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D. Bouvard</a:t>
            </a:r>
            <a:r>
              <a:rPr lang="fr-FR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fr-FR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. Bouchet</a:t>
            </a:r>
            <a:r>
              <a:rPr lang="fr-FR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fr-FR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F. Laurent</a:t>
            </a:r>
            <a:r>
              <a:rPr lang="fr-FR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2,3,7</a:t>
            </a:r>
            <a:r>
              <a:rPr lang="fr-FR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. Diot</a:t>
            </a:r>
            <a:r>
              <a:rPr lang="fr-FR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</a:p>
          <a:p>
            <a:pPr>
              <a:spcAft>
                <a:spcPts val="1000"/>
              </a:spcAft>
            </a:pPr>
            <a:endParaRPr lang="fr-FR" sz="1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600"/>
              </a:spcAft>
            </a:pPr>
            <a:r>
              <a:rPr lang="fr-FR" sz="14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fr-FR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IRI - Centre International de Recherche en Infectiologie, Inserm, U1111, Université Claude Bernard Lyon 1, CNRS, UMR5308, École Normale Supérieure de Lyon, Université Lyon, Lyon, France.</a:t>
            </a:r>
            <a:endParaRPr lang="fr-FR" sz="1400" baseline="300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indent="-125730" algn="just">
              <a:spcAft>
                <a:spcPts val="600"/>
              </a:spcAft>
            </a:pPr>
            <a:r>
              <a:rPr lang="en-GB" sz="14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epartment of Bacteriology, Institute for Infectious Agents, Hospices Civils de Lyon, Lyon, France</a:t>
            </a:r>
            <a:endParaRPr lang="fr-FR" sz="14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indent="-125730" algn="just">
              <a:spcAft>
                <a:spcPts val="600"/>
              </a:spcAft>
            </a:pPr>
            <a:r>
              <a:rPr lang="fr-FR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fr-FR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gional</a:t>
            </a:r>
            <a:r>
              <a:rPr lang="fr-FR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ference Centre for </a:t>
            </a:r>
            <a:r>
              <a:rPr lang="fr-FR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lex</a:t>
            </a:r>
            <a:r>
              <a:rPr lang="fr-FR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one and Joint Infection (</a:t>
            </a:r>
            <a:r>
              <a:rPr lang="fr-FR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RIOAc</a:t>
            </a:r>
            <a:r>
              <a:rPr lang="fr-FR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yon), Hospices Civils de Lyon, Lyon, France.</a:t>
            </a:r>
          </a:p>
          <a:p>
            <a:pPr algn="just">
              <a:spcAft>
                <a:spcPts val="600"/>
              </a:spcAft>
            </a:pPr>
            <a:r>
              <a:rPr lang="fr-FR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fr-FR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Université de Nantes, Faculté de médecine, EA3826 « Thérapeutiques Cliniques et Expérimentales des Infections », Nantes, France</a:t>
            </a:r>
          </a:p>
          <a:p>
            <a:pPr algn="just">
              <a:spcAft>
                <a:spcPts val="600"/>
              </a:spcAft>
            </a:pPr>
            <a:r>
              <a:rPr lang="fr-FR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fr-FR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RBM, </a:t>
            </a:r>
            <a:r>
              <a:rPr lang="fr-FR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iversity</a:t>
            </a:r>
            <a:r>
              <a:rPr lang="fr-FR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Montpellier, CNRS-5237, 1919 Route de Mende, 34293 Montpellier, France</a:t>
            </a:r>
          </a:p>
          <a:p>
            <a:pPr>
              <a:spcAft>
                <a:spcPts val="600"/>
              </a:spcAft>
            </a:pPr>
            <a:r>
              <a:rPr lang="fr-FR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fr-FR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40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stitut De Génomique Fonctionnelle De Lyon, ENS de Lyon, UMR CNRS 5242, Lyon, France.</a:t>
            </a:r>
            <a:endParaRPr lang="fr-FR" sz="1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600"/>
              </a:spcAft>
            </a:pPr>
            <a:r>
              <a:rPr lang="en-US" sz="14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ational Reference Centre for Staphylococci, Hospices Civils de Lyon, Lyon, France; Department of Clinical Microbiology, Northern Hospital Group, Hospices Civils de Lyon, Lyon, France </a:t>
            </a:r>
            <a:endParaRPr lang="fr-FR" sz="14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indent="-125730" algn="just">
              <a:spcAft>
                <a:spcPts val="600"/>
              </a:spcAft>
            </a:pPr>
            <a:r>
              <a:rPr lang="en-US" sz="14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† 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ese authors contributed equally to this work</a:t>
            </a:r>
            <a:endParaRPr lang="fr-FR" sz="14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Aft>
                <a:spcPts val="10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fr-FR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1000"/>
              </a:spcAft>
            </a:pPr>
            <a:r>
              <a:rPr lang="en-GB" sz="1400" i="1" u="sng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Corresponding author:</a:t>
            </a:r>
            <a:r>
              <a:rPr lang="en-GB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Jérôme JOSSE</a:t>
            </a:r>
            <a:endParaRPr lang="fr-FR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1000"/>
              </a:spcAft>
            </a:pPr>
            <a:r>
              <a:rPr lang="en-GB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erome.josse@univ-lyon1.fr</a:t>
            </a:r>
            <a:endParaRPr lang="fr-FR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DAE1F91-48A6-4941-9721-67131424A6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814C8-1B81-48EB-BA89-BCBB29967637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823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Rouge S2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8"/>
          <a:srcRect l="28130" r="21933"/>
          <a:stretch/>
        </p:blipFill>
        <p:spPr>
          <a:xfrm>
            <a:off x="4657898" y="529932"/>
            <a:ext cx="2876203" cy="4320000"/>
          </a:xfrm>
          <a:prstGeom prst="rect">
            <a:avLst/>
          </a:prstGeom>
        </p:spPr>
      </p:pic>
      <p:pic>
        <p:nvPicPr>
          <p:cNvPr id="5" name="Vert S5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9"/>
          <a:srcRect l="24888" r="25178"/>
          <a:stretch/>
        </p:blipFill>
        <p:spPr>
          <a:xfrm>
            <a:off x="8557951" y="529932"/>
            <a:ext cx="2876204" cy="4320000"/>
          </a:xfrm>
          <a:prstGeom prst="rect">
            <a:avLst/>
          </a:prstGeom>
        </p:spPr>
      </p:pic>
      <p:pic>
        <p:nvPicPr>
          <p:cNvPr id="6" name="PBS S2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 rotWithShape="1">
          <a:blip r:embed="rId10"/>
          <a:srcRect l="24763" r="25160"/>
          <a:stretch/>
        </p:blipFill>
        <p:spPr>
          <a:xfrm>
            <a:off x="757845" y="529932"/>
            <a:ext cx="2876203" cy="4320000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757844" y="5261892"/>
            <a:ext cx="1067631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solidFill>
                  <a:srgbClr val="21212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200" b="1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ffect of </a:t>
            </a:r>
            <a:r>
              <a:rPr lang="en-US" sz="1200" b="1" i="1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. aureus </a:t>
            </a:r>
            <a:r>
              <a:rPr lang="en-US" sz="1200" b="1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8325-4 strain on mice bone after an </a:t>
            </a:r>
            <a:r>
              <a:rPr lang="en-US" sz="1200" b="1" i="1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vivo</a:t>
            </a:r>
            <a:r>
              <a:rPr lang="en-US" sz="1200" b="1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7 days infection.</a:t>
            </a:r>
            <a:endParaRPr lang="fr-FR" sz="12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200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 were infected at the </a:t>
            </a:r>
            <a:r>
              <a:rPr lang="en-US" sz="1200" dirty="0" err="1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dfemur</a:t>
            </a:r>
            <a:r>
              <a:rPr lang="en-US" sz="1200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y trepanation with a 20-gauge needle. Controls were realized using a (A) PBS injection (PBS, n = 4) and infection were carried out using (B) the invasive-competent </a:t>
            </a:r>
            <a:r>
              <a:rPr lang="en-US" sz="1200" i="1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. aureus </a:t>
            </a:r>
            <a:r>
              <a:rPr lang="en-US" sz="1200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8325-4 strain (n=13) or (C) invasive-incompetent </a:t>
            </a:r>
            <a:r>
              <a:rPr lang="en-US" sz="1200" i="1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. aureus </a:t>
            </a:r>
            <a:r>
              <a:rPr lang="en-US" sz="1200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8325-4</a:t>
            </a:r>
            <a:r>
              <a:rPr lang="en-US" sz="1200" baseline="30000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∆fnbAB </a:t>
            </a:r>
            <a:r>
              <a:rPr lang="en-US" sz="1200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ain (n=13). Videos were generated after microtomography (Phoenix </a:t>
            </a:r>
            <a:r>
              <a:rPr lang="en-US" sz="1200" dirty="0" err="1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anotom</a:t>
            </a:r>
            <a:r>
              <a:rPr lang="en-US" sz="1200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® S, GE) and 3D reconstruction (Phoenix </a:t>
            </a:r>
            <a:r>
              <a:rPr lang="en-US" sz="1200" dirty="0" err="1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tosx</a:t>
            </a:r>
            <a:r>
              <a:rPr lang="en-US" sz="1200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c, GE).</a:t>
            </a:r>
            <a:endParaRPr lang="fr-FR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ZoneTexte 8"/>
          <p:cNvSpPr txBox="1"/>
          <p:nvPr/>
        </p:nvSpPr>
        <p:spPr>
          <a:xfrm>
            <a:off x="413560" y="160600"/>
            <a:ext cx="3442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0" name="ZoneTexte 9"/>
          <p:cNvSpPr txBox="1"/>
          <p:nvPr/>
        </p:nvSpPr>
        <p:spPr>
          <a:xfrm>
            <a:off x="4161214" y="160600"/>
            <a:ext cx="3442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1" name="ZoneTexte 10"/>
          <p:cNvSpPr txBox="1"/>
          <p:nvPr/>
        </p:nvSpPr>
        <p:spPr>
          <a:xfrm>
            <a:off x="7905073" y="163258"/>
            <a:ext cx="3442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" name="Espace réservé du numéro de diapositive 1">
            <a:extLst>
              <a:ext uri="{FF2B5EF4-FFF2-40B4-BE49-F238E27FC236}">
                <a16:creationId xmlns:a16="http://schemas.microsoft.com/office/drawing/2014/main" id="{6D6910C6-A594-4081-9F4D-FB63D9E57F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814C8-1B81-48EB-BA89-BCBB29967637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404939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BS S1 14j (2018_12_28 10_46_57 UTC)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757845" y="529932"/>
            <a:ext cx="2879999" cy="4320000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413560" y="160600"/>
            <a:ext cx="3442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pic>
        <p:nvPicPr>
          <p:cNvPr id="6" name="GM1S2 7j (2018_12_28 10_46_57 UTC)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9"/>
          <a:srcRect l="25390" r="24676"/>
          <a:stretch/>
        </p:blipFill>
        <p:spPr>
          <a:xfrm>
            <a:off x="4657898" y="529932"/>
            <a:ext cx="2876204" cy="4320000"/>
          </a:xfrm>
          <a:prstGeom prst="rect">
            <a:avLst/>
          </a:prstGeom>
        </p:spPr>
      </p:pic>
      <p:pic>
        <p:nvPicPr>
          <p:cNvPr id="8" name="GM2S3 7j (2018_12_28 10_46_57 UTC)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8554156" y="529932"/>
            <a:ext cx="2880000" cy="4320000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757844" y="5219264"/>
            <a:ext cx="1067631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solidFill>
                  <a:srgbClr val="21212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sz="1200" b="1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ffect of </a:t>
            </a:r>
            <a:r>
              <a:rPr lang="en-US" sz="1200" b="1" i="1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. aureus </a:t>
            </a:r>
            <a:r>
              <a:rPr lang="en-US" sz="1200" b="1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inical strains on mice bone after an </a:t>
            </a:r>
            <a:r>
              <a:rPr lang="en-US" sz="1200" b="1" i="1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vivo</a:t>
            </a:r>
            <a:r>
              <a:rPr lang="en-US" sz="1200" b="1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7 days infection.</a:t>
            </a:r>
            <a:endParaRPr lang="fr-FR" sz="12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 were infected at the </a:t>
            </a:r>
            <a:r>
              <a:rPr lang="en-US" sz="1200" dirty="0" err="1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dfemur</a:t>
            </a:r>
            <a:r>
              <a:rPr lang="en-US" sz="1200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y trepanation with a 20-gauge needle. Controls were realized using (A) a PBS injection (PBS, n = 4) and infection were carried out using a clinical strain isolated during (B) the initial (n=5) or (C) relapse (n=5) phase of a bone infection. Videos </a:t>
            </a:r>
            <a:r>
              <a:rPr lang="en-US" sz="120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ere generated </a:t>
            </a:r>
            <a:r>
              <a:rPr lang="en-US" sz="1200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ter </a:t>
            </a:r>
            <a:r>
              <a:rPr lang="en-US" sz="1200" dirty="0" err="1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tomography</a:t>
            </a:r>
            <a:r>
              <a:rPr lang="en-US" sz="1200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Phoenix </a:t>
            </a:r>
            <a:r>
              <a:rPr lang="en-US" sz="1200" dirty="0" err="1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anotom</a:t>
            </a:r>
            <a:r>
              <a:rPr lang="en-US" sz="1200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® S, GE) and 3D reconstruction (Phoenix </a:t>
            </a:r>
            <a:r>
              <a:rPr lang="en-US" sz="1200" dirty="0" err="1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tosx</a:t>
            </a:r>
            <a:r>
              <a:rPr lang="en-US" sz="1200" dirty="0">
                <a:solidFill>
                  <a:srgbClr val="21212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c, GE).</a:t>
            </a:r>
            <a:endParaRPr lang="fr-FR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4161214" y="160600"/>
            <a:ext cx="3442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2" name="ZoneTexte 11"/>
          <p:cNvSpPr txBox="1"/>
          <p:nvPr/>
        </p:nvSpPr>
        <p:spPr>
          <a:xfrm>
            <a:off x="7905073" y="163258"/>
            <a:ext cx="3442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" name="Espace réservé du numéro de diapositive 1">
            <a:extLst>
              <a:ext uri="{FF2B5EF4-FFF2-40B4-BE49-F238E27FC236}">
                <a16:creationId xmlns:a16="http://schemas.microsoft.com/office/drawing/2014/main" id="{14BC524D-2C8D-4245-8523-BBEFA3EE01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814C8-1B81-48EB-BA89-BCBB29967637}" type="slidenum">
              <a:rPr lang="fr-FR" smtClean="0"/>
              <a:t>3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6804171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</TotalTime>
  <Words>477</Words>
  <Application>Microsoft Office PowerPoint</Application>
  <PresentationFormat>Grand écran</PresentationFormat>
  <Paragraphs>28</Paragraphs>
  <Slides>3</Slides>
  <Notes>0</Notes>
  <HiddenSlides>0</HiddenSlides>
  <MMClips>6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  <vt:lpstr>Présentation PowerPoint</vt:lpstr>
    </vt:vector>
  </TitlesOfParts>
  <Company>bioMerieux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OUTON William</dc:creator>
  <cp:lastModifiedBy>Jérôme Josse</cp:lastModifiedBy>
  <cp:revision>12</cp:revision>
  <dcterms:created xsi:type="dcterms:W3CDTF">2020-08-25T12:07:28Z</dcterms:created>
  <dcterms:modified xsi:type="dcterms:W3CDTF">2021-02-12T10:15:44Z</dcterms:modified>
</cp:coreProperties>
</file>